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2.xml" ContentType="application/vnd.openxmlformats-officedocument.presentationml.tags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</p:sldIdLst>
  <p:sldSz cx="12192000" cy="6858000"/>
  <p:notesSz cx="6858000" cy="9144000"/>
  <p:custDataLst>
    <p:tags r:id="rId3"/>
  </p:custDataLst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2" d="100"/>
          <a:sy n="82" d="100"/>
        </p:scale>
        <p:origin x="643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tags" Target="tags/tag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iyoshi, Tetsuaki" userId="6c935de5-33b1-478a-9e60-dfb4611f244b" providerId="ADAL" clId="{00F41F50-551C-4C08-A645-E7E8813281EB}"/>
    <pc:docChg chg="delSld delMainMaster">
      <pc:chgData name="Hiyoshi, Tetsuaki" userId="6c935de5-33b1-478a-9e60-dfb4611f244b" providerId="ADAL" clId="{00F41F50-551C-4C08-A645-E7E8813281EB}" dt="2023-08-09T12:12:54.891" v="0" actId="47"/>
      <pc:docMkLst>
        <pc:docMk/>
      </pc:docMkLst>
      <pc:sldChg chg="del">
        <pc:chgData name="Hiyoshi, Tetsuaki" userId="6c935de5-33b1-478a-9e60-dfb4611f244b" providerId="ADAL" clId="{00F41F50-551C-4C08-A645-E7E8813281EB}" dt="2023-08-09T12:12:54.891" v="0" actId="47"/>
        <pc:sldMkLst>
          <pc:docMk/>
          <pc:sldMk cId="239280867" sldId="256"/>
        </pc:sldMkLst>
      </pc:sldChg>
      <pc:sldMasterChg chg="del delSldLayout">
        <pc:chgData name="Hiyoshi, Tetsuaki" userId="6c935de5-33b1-478a-9e60-dfb4611f244b" providerId="ADAL" clId="{00F41F50-551C-4C08-A645-E7E8813281EB}" dt="2023-08-09T12:12:54.891" v="0" actId="47"/>
        <pc:sldMasterMkLst>
          <pc:docMk/>
          <pc:sldMasterMk cId="1494434181" sldId="2147483648"/>
        </pc:sldMasterMkLst>
        <pc:sldLayoutChg chg="del">
          <pc:chgData name="Hiyoshi, Tetsuaki" userId="6c935de5-33b1-478a-9e60-dfb4611f244b" providerId="ADAL" clId="{00F41F50-551C-4C08-A645-E7E8813281EB}" dt="2023-08-09T12:12:54.891" v="0" actId="47"/>
          <pc:sldLayoutMkLst>
            <pc:docMk/>
            <pc:sldMasterMk cId="1494434181" sldId="2147483648"/>
            <pc:sldLayoutMk cId="2232445703" sldId="2147483649"/>
          </pc:sldLayoutMkLst>
        </pc:sldLayoutChg>
        <pc:sldLayoutChg chg="del">
          <pc:chgData name="Hiyoshi, Tetsuaki" userId="6c935de5-33b1-478a-9e60-dfb4611f244b" providerId="ADAL" clId="{00F41F50-551C-4C08-A645-E7E8813281EB}" dt="2023-08-09T12:12:54.891" v="0" actId="47"/>
          <pc:sldLayoutMkLst>
            <pc:docMk/>
            <pc:sldMasterMk cId="1494434181" sldId="2147483648"/>
            <pc:sldLayoutMk cId="140086974" sldId="2147483650"/>
          </pc:sldLayoutMkLst>
        </pc:sldLayoutChg>
        <pc:sldLayoutChg chg="del">
          <pc:chgData name="Hiyoshi, Tetsuaki" userId="6c935de5-33b1-478a-9e60-dfb4611f244b" providerId="ADAL" clId="{00F41F50-551C-4C08-A645-E7E8813281EB}" dt="2023-08-09T12:12:54.891" v="0" actId="47"/>
          <pc:sldLayoutMkLst>
            <pc:docMk/>
            <pc:sldMasterMk cId="1494434181" sldId="2147483648"/>
            <pc:sldLayoutMk cId="2343240082" sldId="2147483651"/>
          </pc:sldLayoutMkLst>
        </pc:sldLayoutChg>
        <pc:sldLayoutChg chg="del">
          <pc:chgData name="Hiyoshi, Tetsuaki" userId="6c935de5-33b1-478a-9e60-dfb4611f244b" providerId="ADAL" clId="{00F41F50-551C-4C08-A645-E7E8813281EB}" dt="2023-08-09T12:12:54.891" v="0" actId="47"/>
          <pc:sldLayoutMkLst>
            <pc:docMk/>
            <pc:sldMasterMk cId="1494434181" sldId="2147483648"/>
            <pc:sldLayoutMk cId="2853784761" sldId="2147483652"/>
          </pc:sldLayoutMkLst>
        </pc:sldLayoutChg>
        <pc:sldLayoutChg chg="del">
          <pc:chgData name="Hiyoshi, Tetsuaki" userId="6c935de5-33b1-478a-9e60-dfb4611f244b" providerId="ADAL" clId="{00F41F50-551C-4C08-A645-E7E8813281EB}" dt="2023-08-09T12:12:54.891" v="0" actId="47"/>
          <pc:sldLayoutMkLst>
            <pc:docMk/>
            <pc:sldMasterMk cId="1494434181" sldId="2147483648"/>
            <pc:sldLayoutMk cId="3031033090" sldId="2147483653"/>
          </pc:sldLayoutMkLst>
        </pc:sldLayoutChg>
        <pc:sldLayoutChg chg="del">
          <pc:chgData name="Hiyoshi, Tetsuaki" userId="6c935de5-33b1-478a-9e60-dfb4611f244b" providerId="ADAL" clId="{00F41F50-551C-4C08-A645-E7E8813281EB}" dt="2023-08-09T12:12:54.891" v="0" actId="47"/>
          <pc:sldLayoutMkLst>
            <pc:docMk/>
            <pc:sldMasterMk cId="1494434181" sldId="2147483648"/>
            <pc:sldLayoutMk cId="2377342400" sldId="2147483654"/>
          </pc:sldLayoutMkLst>
        </pc:sldLayoutChg>
        <pc:sldLayoutChg chg="del">
          <pc:chgData name="Hiyoshi, Tetsuaki" userId="6c935de5-33b1-478a-9e60-dfb4611f244b" providerId="ADAL" clId="{00F41F50-551C-4C08-A645-E7E8813281EB}" dt="2023-08-09T12:12:54.891" v="0" actId="47"/>
          <pc:sldLayoutMkLst>
            <pc:docMk/>
            <pc:sldMasterMk cId="1494434181" sldId="2147483648"/>
            <pc:sldLayoutMk cId="17919534" sldId="2147483655"/>
          </pc:sldLayoutMkLst>
        </pc:sldLayoutChg>
        <pc:sldLayoutChg chg="del">
          <pc:chgData name="Hiyoshi, Tetsuaki" userId="6c935de5-33b1-478a-9e60-dfb4611f244b" providerId="ADAL" clId="{00F41F50-551C-4C08-A645-E7E8813281EB}" dt="2023-08-09T12:12:54.891" v="0" actId="47"/>
          <pc:sldLayoutMkLst>
            <pc:docMk/>
            <pc:sldMasterMk cId="1494434181" sldId="2147483648"/>
            <pc:sldLayoutMk cId="2790851868" sldId="2147483656"/>
          </pc:sldLayoutMkLst>
        </pc:sldLayoutChg>
        <pc:sldLayoutChg chg="del">
          <pc:chgData name="Hiyoshi, Tetsuaki" userId="6c935de5-33b1-478a-9e60-dfb4611f244b" providerId="ADAL" clId="{00F41F50-551C-4C08-A645-E7E8813281EB}" dt="2023-08-09T12:12:54.891" v="0" actId="47"/>
          <pc:sldLayoutMkLst>
            <pc:docMk/>
            <pc:sldMasterMk cId="1494434181" sldId="2147483648"/>
            <pc:sldLayoutMk cId="1424633658" sldId="2147483657"/>
          </pc:sldLayoutMkLst>
        </pc:sldLayoutChg>
        <pc:sldLayoutChg chg="del">
          <pc:chgData name="Hiyoshi, Tetsuaki" userId="6c935de5-33b1-478a-9e60-dfb4611f244b" providerId="ADAL" clId="{00F41F50-551C-4C08-A645-E7E8813281EB}" dt="2023-08-09T12:12:54.891" v="0" actId="47"/>
          <pc:sldLayoutMkLst>
            <pc:docMk/>
            <pc:sldMasterMk cId="1494434181" sldId="2147483648"/>
            <pc:sldLayoutMk cId="1491135869" sldId="2147483658"/>
          </pc:sldLayoutMkLst>
        </pc:sldLayoutChg>
        <pc:sldLayoutChg chg="del">
          <pc:chgData name="Hiyoshi, Tetsuaki" userId="6c935de5-33b1-478a-9e60-dfb4611f244b" providerId="ADAL" clId="{00F41F50-551C-4C08-A645-E7E8813281EB}" dt="2023-08-09T12:12:54.891" v="0" actId="47"/>
          <pc:sldLayoutMkLst>
            <pc:docMk/>
            <pc:sldMasterMk cId="1494434181" sldId="2147483648"/>
            <pc:sldLayoutMk cId="3416290436" sldId="2147483659"/>
          </pc:sldLayoutMkLst>
        </pc:sldLayoutChg>
      </pc:sldMasterChg>
    </pc:docChg>
  </pc:docChgLst>
  <pc:docChgLst>
    <pc:chgData name="Hiyoshi, Tetsuaki" userId="6c935de5-33b1-478a-9e60-dfb4611f244b" providerId="ADAL" clId="{7EEA70A7-432F-4015-A962-959E1831A5E8}"/>
    <pc:docChg chg="modSld">
      <pc:chgData name="Hiyoshi, Tetsuaki" userId="6c935de5-33b1-478a-9e60-dfb4611f244b" providerId="ADAL" clId="{7EEA70A7-432F-4015-A962-959E1831A5E8}" dt="2023-10-12T09:21:33.689" v="3" actId="20577"/>
      <pc:docMkLst>
        <pc:docMk/>
      </pc:docMkLst>
      <pc:sldChg chg="modSp mod">
        <pc:chgData name="Hiyoshi, Tetsuaki" userId="6c935de5-33b1-478a-9e60-dfb4611f244b" providerId="ADAL" clId="{7EEA70A7-432F-4015-A962-959E1831A5E8}" dt="2023-10-12T09:21:33.689" v="3" actId="20577"/>
        <pc:sldMkLst>
          <pc:docMk/>
          <pc:sldMk cId="2606050260" sldId="261"/>
        </pc:sldMkLst>
        <pc:spChg chg="mod">
          <ac:chgData name="Hiyoshi, Tetsuaki" userId="6c935de5-33b1-478a-9e60-dfb4611f244b" providerId="ADAL" clId="{7EEA70A7-432F-4015-A962-959E1831A5E8}" dt="2023-10-12T09:21:33.689" v="3" actId="20577"/>
          <ac:spMkLst>
            <pc:docMk/>
            <pc:sldMk cId="2606050260" sldId="261"/>
            <ac:spMk id="2" creationId="{3CB08267-FF44-4F12-B107-2DF770D2F801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1DF4CC-4525-4FC5-9B4F-452C34440ED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DF9E1AA-A107-4B57-BB34-E63CF07E675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CB8B86-9FFB-4992-8BE8-391BB57747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608BE-1148-44D1-916F-B69F203A7669}" type="datetimeFigureOut">
              <a:rPr lang="en-US" smtClean="0"/>
              <a:t>10/1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A8CAA0-BF05-4F76-BA43-DBE0120486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2659F5-E65B-439F-B833-9F3EB25F34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8FB82-69FE-497F-BD78-F53D05E9CA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66439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F96D54-51DE-407A-9CDA-73773A16D2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9F77BC2-7403-4790-894B-C8D42CFBE5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653CFE-34FD-435A-8F1A-DD3D0AE917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608BE-1148-44D1-916F-B69F203A7669}" type="datetimeFigureOut">
              <a:rPr lang="en-US" smtClean="0"/>
              <a:t>10/1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13D870-35C8-4135-BA28-FCDC2E642F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E79F16-D8E8-448A-A69B-FD1D457D74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8FB82-69FE-497F-BD78-F53D05E9CA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58333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C3BC23C-097E-4068-95A2-B211F4B1290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69A963C-7EA5-4860-A128-4CD9B3DD498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BF909E-331E-4F3D-8186-0AE52AFC37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608BE-1148-44D1-916F-B69F203A7669}" type="datetimeFigureOut">
              <a:rPr lang="en-US" smtClean="0"/>
              <a:t>10/1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FBE8FA-A876-4139-9E48-E4545FF1BC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FFF23E-A1F7-44FF-80C9-D15FAC7051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8FB82-69FE-497F-BD78-F53D05E9CA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26554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3CAFB1-C19F-4CAC-A71E-DD70839DF8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F1B303B-586B-4DF2-B3C0-808C1E87CEC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8B14FA-FAD7-4196-B440-2E41FDFD27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608BE-1148-44D1-916F-B69F203A7669}" type="datetimeFigureOut">
              <a:rPr lang="en-US" smtClean="0"/>
              <a:t>10/1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4CCE9C-7676-49F9-B5D2-207F0B0AB9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10776B-9F2A-45BD-B9D6-0E32E5281E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8FB82-69FE-497F-BD78-F53D05E9CA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06596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DC20FE-860E-404F-8BF1-4343CDD0C7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AFBA1E-92E7-4304-92EB-B93F962F4B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CB2F25-CF97-4181-A522-04E580B185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608BE-1148-44D1-916F-B69F203A7669}" type="datetimeFigureOut">
              <a:rPr lang="en-US" smtClean="0"/>
              <a:t>10/1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2013D3-54A8-40F0-AAD5-1977D4B63C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EEA329-B011-4FBB-996C-6C6672A068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8FB82-69FE-497F-BD78-F53D05E9CA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55577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B47430-FCEE-4F09-81D3-AAEA42EAEF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CABF28B-CEF0-44B1-9AAB-06971CA6182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109889E-2832-428C-9D86-52B97F635F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CAE058B-FC9E-4AAA-B0C1-9DC11D8B1A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608BE-1148-44D1-916F-B69F203A7669}" type="datetimeFigureOut">
              <a:rPr lang="en-US" smtClean="0"/>
              <a:t>10/12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85BD2AE-2730-4C07-A21A-515ABB4FE9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E6EC90F-478F-40AC-AD0E-97A1C3E670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8FB82-69FE-497F-BD78-F53D05E9CA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44381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E2E44C-A84C-490D-9909-0F78ECBA5F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80B1B7D-C370-43B2-B448-120281D137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08A7290-C839-40C5-8F99-5B5373CBFE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69DCAE1-B47B-4D80-89B8-32CEBA78487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42C25FF-44C6-4C5A-A3B7-39BCD5EA876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2685FC7-B2DD-490D-91ED-AABF462285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608BE-1148-44D1-916F-B69F203A7669}" type="datetimeFigureOut">
              <a:rPr lang="en-US" smtClean="0"/>
              <a:t>10/12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7B24E2E-78B8-49F6-8813-05FE04F7F8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E96578D-EFC1-43BC-A538-C7CC5262F3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8FB82-69FE-497F-BD78-F53D05E9CA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29398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7C5CA2-2857-4247-86BD-3DB1C2E02C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B02D60B-FF72-4630-9418-EBD7DA8DFD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608BE-1148-44D1-916F-B69F203A7669}" type="datetimeFigureOut">
              <a:rPr lang="en-US" smtClean="0"/>
              <a:t>10/12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B3A4AA9-0C96-4FE0-8DAC-05653CEAF8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844BA52-BD3D-4CC5-B28F-F56E772178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8FB82-69FE-497F-BD78-F53D05E9CA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50393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FB33DD9-E6F9-4653-8E12-2DB82C9947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608BE-1148-44D1-916F-B69F203A7669}" type="datetimeFigureOut">
              <a:rPr lang="en-US" smtClean="0"/>
              <a:t>10/12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9FFD711-D8F7-4DC6-B2AF-F1D60AB7EB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DB304B7-FD51-4711-AFDA-E097EA2555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8FB82-69FE-497F-BD78-F53D05E9CA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1981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F8698B-E71C-4328-B7B2-27B131815A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AF5155B-5541-408E-9CD9-9BD0A7F6978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5A3AEE5-4456-48E1-A491-74C2678798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221FAA-1192-48F5-BD18-A7573A0374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608BE-1148-44D1-916F-B69F203A7669}" type="datetimeFigureOut">
              <a:rPr lang="en-US" smtClean="0"/>
              <a:t>10/12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D682905-8AFB-47B3-B09C-C7A7F6D5A4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0FC9528-18E6-4201-991D-0EB7B1C6F4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8FB82-69FE-497F-BD78-F53D05E9CA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809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374931-E31A-433B-B16F-C7135401CB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6B3B32B-A9DB-4F1C-83EB-08CBCE9BCDB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6FE8CAE-8AE1-4A61-831B-B4EB018CCB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2390171-9FD1-469D-8DD8-9FDB598389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608BE-1148-44D1-916F-B69F203A7669}" type="datetimeFigureOut">
              <a:rPr lang="en-US" smtClean="0"/>
              <a:t>10/12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AC1649C-355F-48DA-B257-B9A1782ED0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B97ABE1-D8A2-4677-A745-86B4B1B9B9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8FB82-69FE-497F-BD78-F53D05E9CA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06722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2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image" Target="../media/image1.emf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oleObject" Target="../embeddings/oleObject1.bin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オブジェクト 7" hidden="1">
            <a:extLst>
              <a:ext uri="{FF2B5EF4-FFF2-40B4-BE49-F238E27FC236}">
                <a16:creationId xmlns:a16="http://schemas.microsoft.com/office/drawing/2014/main" id="{F036EE81-27C1-9EE2-AA2D-C1B154107C67}"/>
              </a:ext>
            </a:extLst>
          </p:cNvPr>
          <p:cNvGraphicFramePr>
            <a:graphicFrameLocks noChangeAspect="1"/>
          </p:cNvGraphicFramePr>
          <p:nvPr userDrawn="1">
            <p:custDataLst>
              <p:tags r:id="rId13"/>
            </p:custDataLst>
            <p:extLst>
              <p:ext uri="{D42A27DB-BD31-4B8C-83A1-F6EECF244321}">
                <p14:modId xmlns:p14="http://schemas.microsoft.com/office/powerpoint/2010/main" val="3218601205"/>
              </p:ext>
            </p:extLst>
          </p:nvPr>
        </p:nvGraphicFramePr>
        <p:xfrm>
          <a:off x="1588" y="1588"/>
          <a:ext cx="1588" cy="1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think-cell スライド" r:id="rId14" imgW="473" imgH="473" progId="TCLayout.ActiveDocument.1">
                  <p:embed/>
                </p:oleObj>
              </mc:Choice>
              <mc:Fallback>
                <p:oleObj name="think-cell スライド" r:id="rId14" imgW="473" imgH="473" progId="TCLayout.ActiveDocument.1">
                  <p:embed/>
                  <p:pic>
                    <p:nvPicPr>
                      <p:cNvPr id="8" name="オブジェクト 7" hidden="1">
                        <a:extLst>
                          <a:ext uri="{FF2B5EF4-FFF2-40B4-BE49-F238E27FC236}">
                            <a16:creationId xmlns:a16="http://schemas.microsoft.com/office/drawing/2014/main" id="{F036EE81-27C1-9EE2-AA2D-C1B154107C6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1588" y="1588"/>
                        <a:ext cx="1588" cy="1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1091A09-BB3B-48C7-BB12-95409D7263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4B80C97-1464-4DB6-B8EC-0E8D685246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B96130-E7B9-41BC-AF10-7DD5232B46D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3608BE-1148-44D1-916F-B69F203A7669}" type="datetimeFigureOut">
              <a:rPr lang="en-US" smtClean="0"/>
              <a:t>10/1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86118C-5B80-49E0-84B9-4DE21A45E38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0974F5-20EE-4BEF-A3AB-5A489D08C9F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88FB82-69FE-497F-BD78-F53D05E9CA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42519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9A876280-6155-4675-8AA7-294B6C21C9F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75867" y="1616743"/>
            <a:ext cx="4861953" cy="2567933"/>
          </a:xfrm>
          <a:prstGeom prst="rect">
            <a:avLst/>
          </a:prstGeom>
        </p:spPr>
      </p:pic>
      <p:grpSp>
        <p:nvGrpSpPr>
          <p:cNvPr id="5" name="Group 4">
            <a:extLst>
              <a:ext uri="{FF2B5EF4-FFF2-40B4-BE49-F238E27FC236}">
                <a16:creationId xmlns:a16="http://schemas.microsoft.com/office/drawing/2014/main" id="{253566AF-1B2B-45FD-920F-3C58C46276CD}"/>
              </a:ext>
            </a:extLst>
          </p:cNvPr>
          <p:cNvGrpSpPr/>
          <p:nvPr/>
        </p:nvGrpSpPr>
        <p:grpSpPr>
          <a:xfrm>
            <a:off x="3339100" y="1815046"/>
            <a:ext cx="1623831" cy="1659619"/>
            <a:chOff x="4750657" y="1647691"/>
            <a:chExt cx="2380122" cy="2380122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F2687F5A-4A74-4D32-9462-2559AF3606F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 rot="-5400000">
              <a:off x="4750657" y="1647691"/>
              <a:ext cx="2380122" cy="2380122"/>
            </a:xfrm>
            <a:prstGeom prst="rect">
              <a:avLst/>
            </a:prstGeom>
          </p:spPr>
        </p:pic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0084C88D-D998-4558-95EF-C9E9A63E5E27}"/>
                </a:ext>
              </a:extLst>
            </p:cNvPr>
            <p:cNvSpPr/>
            <p:nvPr/>
          </p:nvSpPr>
          <p:spPr>
            <a:xfrm>
              <a:off x="5640448" y="2517990"/>
              <a:ext cx="429768" cy="429768"/>
            </a:xfrm>
            <a:prstGeom prst="rect">
              <a:avLst/>
            </a:prstGeom>
            <a:noFill/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CBFB258B-053D-4501-A6C0-8FC92E327BC8}"/>
              </a:ext>
            </a:extLst>
          </p:cNvPr>
          <p:cNvSpPr txBox="1"/>
          <p:nvPr/>
        </p:nvSpPr>
        <p:spPr>
          <a:xfrm>
            <a:off x="3285114" y="3122445"/>
            <a:ext cx="22507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>
                <a:ln>
                  <a:noFill/>
                </a:ln>
                <a:solidFill>
                  <a:srgbClr val="FFFF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2 </a:t>
            </a:r>
            <a:r>
              <a:rPr kumimoji="0" lang="ru-RU" sz="1400" b="0" i="0" u="none" strike="noStrike" kern="1200" cap="none" spc="0" normalizeH="0" baseline="0" noProof="0">
                <a:ln>
                  <a:noFill/>
                </a:ln>
                <a:solidFill>
                  <a:srgbClr val="FFFF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х</a:t>
            </a:r>
            <a:r>
              <a:rPr kumimoji="0" lang="en-US" sz="1400" b="0" i="0" u="none" strike="noStrike" kern="1200" cap="none" spc="0" normalizeH="0" baseline="0" noProof="0">
                <a:ln>
                  <a:noFill/>
                </a:ln>
                <a:solidFill>
                  <a:srgbClr val="FFFF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2 </a:t>
            </a:r>
            <a:r>
              <a:rPr kumimoji="0" lang="ru-RU" sz="1400" b="0" i="0" u="none" strike="noStrike" kern="1200" cap="none" spc="0" normalizeH="0" baseline="0" noProof="0">
                <a:ln>
                  <a:noFill/>
                </a:ln>
                <a:solidFill>
                  <a:srgbClr val="FFFF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х</a:t>
            </a:r>
            <a:r>
              <a:rPr kumimoji="0" lang="en-US" sz="1400" b="0" i="0" u="none" strike="noStrike" kern="1200" cap="none" spc="0" normalizeH="0" baseline="0" noProof="0">
                <a:ln>
                  <a:noFill/>
                </a:ln>
                <a:solidFill>
                  <a:srgbClr val="FFFF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2 mm</a:t>
            </a:r>
            <a:r>
              <a:rPr kumimoji="0" lang="en-US" sz="1400" b="0" i="0" u="none" strike="noStrike" kern="1200" cap="none" spc="0" normalizeH="0" baseline="30000" noProof="0">
                <a:ln>
                  <a:noFill/>
                </a:ln>
                <a:solidFill>
                  <a:srgbClr val="FFFF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3 </a:t>
            </a:r>
            <a:r>
              <a:rPr kumimoji="0" lang="en-US" sz="1400" b="0" i="0" u="none" strike="noStrike" kern="1200" cap="none" spc="0" normalizeH="0" baseline="0" noProof="0">
                <a:ln>
                  <a:noFill/>
                </a:ln>
                <a:solidFill>
                  <a:srgbClr val="FFFF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for MR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6C6369D-794D-40F0-B488-558FA393C527}"/>
              </a:ext>
            </a:extLst>
          </p:cNvPr>
          <p:cNvSpPr txBox="1"/>
          <p:nvPr/>
        </p:nvSpPr>
        <p:spPr>
          <a:xfrm rot="-5400000">
            <a:off x="-28517" y="2651994"/>
            <a:ext cx="13904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Magnitude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9C7D3C9-4414-487E-964D-FA466FD118B4}"/>
              </a:ext>
            </a:extLst>
          </p:cNvPr>
          <p:cNvSpPr txBox="1"/>
          <p:nvPr/>
        </p:nvSpPr>
        <p:spPr>
          <a:xfrm>
            <a:off x="2378679" y="2110665"/>
            <a:ext cx="7974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Water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A2E31D5-B6D8-48AE-9980-1C41DFF90A93}"/>
              </a:ext>
            </a:extLst>
          </p:cNvPr>
          <p:cNvSpPr txBox="1"/>
          <p:nvPr/>
        </p:nvSpPr>
        <p:spPr>
          <a:xfrm>
            <a:off x="1081810" y="1438382"/>
            <a:ext cx="9554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3000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</a:t>
            </a:r>
            <a:r>
              <a: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 MRS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6DF125A-F511-4C7A-837B-DF85FCBC4D63}"/>
              </a:ext>
            </a:extLst>
          </p:cNvPr>
          <p:cNvSpPr txBox="1"/>
          <p:nvPr/>
        </p:nvSpPr>
        <p:spPr>
          <a:xfrm>
            <a:off x="3578431" y="4042597"/>
            <a:ext cx="17505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Frequency (Hz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3A3A75D-21F3-4D91-A33B-99645307A045}"/>
              </a:ext>
            </a:extLst>
          </p:cNvPr>
          <p:cNvSpPr txBox="1"/>
          <p:nvPr/>
        </p:nvSpPr>
        <p:spPr>
          <a:xfrm>
            <a:off x="3981423" y="1746227"/>
            <a:ext cx="10036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Leg muscle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1FD97BF-C9DB-4FE0-86E0-C2DD364908EB}"/>
              </a:ext>
            </a:extLst>
          </p:cNvPr>
          <p:cNvSpPr txBox="1"/>
          <p:nvPr/>
        </p:nvSpPr>
        <p:spPr>
          <a:xfrm>
            <a:off x="3339437" y="3563377"/>
            <a:ext cx="7974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Fat</a:t>
            </a:r>
          </a:p>
        </p:txBody>
      </p:sp>
      <p:pic>
        <p:nvPicPr>
          <p:cNvPr id="15" name="Picture 14" descr="Chart, histogram&#10;&#10;Description automatically generated">
            <a:extLst>
              <a:ext uri="{FF2B5EF4-FFF2-40B4-BE49-F238E27FC236}">
                <a16:creationId xmlns:a16="http://schemas.microsoft.com/office/drawing/2014/main" id="{FB0E63DC-E9A5-4240-BB67-A893DFAE9D1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142930" y="1618488"/>
            <a:ext cx="4861953" cy="2567933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6283290F-B113-4217-9F97-E39EE9DCBD54}"/>
              </a:ext>
            </a:extLst>
          </p:cNvPr>
          <p:cNvSpPr txBox="1"/>
          <p:nvPr/>
        </p:nvSpPr>
        <p:spPr>
          <a:xfrm>
            <a:off x="9254334" y="4041648"/>
            <a:ext cx="17505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Frequency (Hz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7395D7F-8C2E-45C4-8CB4-39BF44762B98}"/>
              </a:ext>
            </a:extLst>
          </p:cNvPr>
          <p:cNvSpPr txBox="1"/>
          <p:nvPr/>
        </p:nvSpPr>
        <p:spPr>
          <a:xfrm rot="-5400000">
            <a:off x="5669259" y="2549859"/>
            <a:ext cx="13904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Magnitud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F9B611D-4CAD-4142-AC52-0742E176CB70}"/>
              </a:ext>
            </a:extLst>
          </p:cNvPr>
          <p:cNvSpPr txBox="1"/>
          <p:nvPr/>
        </p:nvSpPr>
        <p:spPr>
          <a:xfrm>
            <a:off x="7972916" y="2047310"/>
            <a:ext cx="7974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Water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C7583EF-D6AE-49C1-BED9-5249683977BF}"/>
              </a:ext>
            </a:extLst>
          </p:cNvPr>
          <p:cNvSpPr txBox="1"/>
          <p:nvPr/>
        </p:nvSpPr>
        <p:spPr>
          <a:xfrm>
            <a:off x="9043831" y="3009985"/>
            <a:ext cx="7974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Fat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AA382E5-145F-416F-B6E7-D78B4F9027DD}"/>
              </a:ext>
            </a:extLst>
          </p:cNvPr>
          <p:cNvSpPr txBox="1"/>
          <p:nvPr/>
        </p:nvSpPr>
        <p:spPr>
          <a:xfrm>
            <a:off x="6648873" y="1438382"/>
            <a:ext cx="36803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3000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</a:t>
            </a:r>
            <a:r>
              <a: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 MRS with water suppression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CB08267-FF44-4F12-B107-2DF770D2F801}"/>
              </a:ext>
            </a:extLst>
          </p:cNvPr>
          <p:cNvSpPr txBox="1"/>
          <p:nvPr/>
        </p:nvSpPr>
        <p:spPr>
          <a:xfrm>
            <a:off x="140853" y="107950"/>
            <a:ext cx="24969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 Fig. 2</a:t>
            </a: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0DBC138-5887-4C5B-0475-489F93E55B88}"/>
              </a:ext>
            </a:extLst>
          </p:cNvPr>
          <p:cNvSpPr txBox="1"/>
          <p:nvPr/>
        </p:nvSpPr>
        <p:spPr>
          <a:xfrm>
            <a:off x="414444" y="1337905"/>
            <a:ext cx="29754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A</a:t>
            </a:r>
            <a:endParaRPr kumimoji="1" lang="ja-JP" altLang="en-US" sz="2400" b="1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3FB8B587-07E9-5230-A4BB-B8BE3B9030A2}"/>
              </a:ext>
            </a:extLst>
          </p:cNvPr>
          <p:cNvSpPr txBox="1"/>
          <p:nvPr/>
        </p:nvSpPr>
        <p:spPr>
          <a:xfrm>
            <a:off x="5983866" y="1337905"/>
            <a:ext cx="29754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B</a:t>
            </a:r>
            <a:endParaRPr kumimoji="1" lang="ja-JP" altLang="en-US" sz="2400" b="1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06050260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UNDODONOTDELETE" val="0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7</Words>
  <Application>Microsoft Office PowerPoint</Application>
  <PresentationFormat>ワイド画面</PresentationFormat>
  <Paragraphs>15</Paragraphs>
  <Slides>1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think-cell スライド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iyoshi, Tetsuaki</dc:creator>
  <cp:lastModifiedBy>Hiyoshi, Tetsuaki</cp:lastModifiedBy>
  <cp:revision>1</cp:revision>
  <dcterms:created xsi:type="dcterms:W3CDTF">2023-08-09T11:44:45Z</dcterms:created>
  <dcterms:modified xsi:type="dcterms:W3CDTF">2023-10-12T09:21:55Z</dcterms:modified>
</cp:coreProperties>
</file>